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81E4B9-F9B4-45F2-81D8-E61C8BD62A0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EA5EE8-9EAB-4940-BEA0-F6BBB7965B6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79C81B-BA35-4E31-A4A5-5704A517A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A3B839-2463-413E-876E-330FB5D2E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43B1BD-7F0C-430F-950C-0461DABB2C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66946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517AA5-5AD4-4AE1-AD6E-8A9DC4E5BF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5B38E27-D113-4D5C-9E78-6C0185CE2A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BD25BE5-3E81-4305-9873-127D189D5B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913C2B-3D36-4E2A-97AB-FA84DD96E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76FE9D-2D3E-44E5-AC12-5877056AB2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65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6F7E6E-5376-45C1-93ED-C73A62CB73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9388605-BE9F-41EB-8624-D181ADC024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B40B39-A33C-47B8-AF9E-D4F70F894D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26A0D2-9283-4BF0-8389-E839660ABB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FDF187-64EF-437E-B25C-34F972A71E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5659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869646-F53F-4C4C-B4A7-29B21AFFB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976674-A532-4DC1-917A-72FB008548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64684D-793A-4C5B-A540-BE05D0F0A6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4235A1-7793-4325-88A0-0EB637231B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46DF33-59C3-4F18-AF03-458FA869FD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5105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CC1E5F-F10F-4586-ABE2-F120B49B7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664831-2178-4623-960F-3FF69F6C3F5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F22BB6-BB79-443E-8761-C0517257C8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5E2E1A-819E-4741-B4C2-062224F87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3B0E9D-A8CB-4527-8DCC-2B543BDB67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85426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1A3B5-C353-4D78-9D5E-0A06ED4C9DF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EEEE2E-408E-44C0-B26D-CFA92C3FF9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1267CE-59EF-4D38-A5C8-BD1F4DFF5D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B7DBE4-4957-46C9-ADFF-887BD3CEC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769FA-3D2C-407D-8A62-C9E4501F6F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58A0C9-1ECF-46B3-8D33-9FC0A7680F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201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99488E-17C7-42A1-BF43-CA3BD5346F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55F7C1-6FD4-4070-94DE-44C01C7C98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D915BA-7746-4054-9A88-8901220B42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D862EF-7E20-486D-A797-55BDEDF368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32CAE8-3376-4C47-8ACC-121B4766D0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F679F26-1B0D-4C67-B2B9-27F2F2542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1EE4A9-026A-4B18-9FA9-455B105ED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11AE85D-C8DC-4126-B847-4785CAC07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5559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3BE888-F187-422E-A8C3-1A6BF96442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E9DF393-1229-4DA4-B78E-3C4BB2B94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36098B-42DF-42DC-9C35-7D37E64AF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6212D39-1E44-450F-B39F-37393CF1E4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019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C5D964C-513A-452E-839E-FDF3969FD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61BA75-92DE-4396-9D68-D69927D5A9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E491B0-D06B-427F-81D8-63A095F77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0325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078784-FD8A-4047-BCD4-C57C76CE4F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FF1912-D2B6-4F57-86C1-A625F5C9485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E39C73-4629-4398-9011-A64EA9543A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615F4A-6C9E-4A05-9D97-57B4FB7BD7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DDA8576-9A9D-417A-97F3-798DFCA42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5B2724-C28E-4114-B031-C0B7D49B0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7766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D922E9-4662-4682-94B3-449F158A5C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6487873-AD73-4BE6-90D0-A529B7E151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15C0E0-61F4-443A-AF04-7F55E162D4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4C14F8-8FCA-4AE5-81FA-AEED5D310E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327DA0E-DEEC-463F-AC20-A895758871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A1A025-45C8-41E3-908F-6E5094B5C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108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E9C8B72-3B97-413E-8833-4D8A990CD3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3A7CAF-3E76-46A0-9791-4EE605E379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698C71-8C4E-4C60-8D49-3DB9841A9E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D60D9A-F89C-4FBF-9B1F-4B3E0F13BAFE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133EE8-E9C1-4BB6-BBEF-D2931E87C2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D18B28-B2AD-42A7-9A3C-BB1C0977470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04F39-F68C-42E6-B9F5-C22E75DDF7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1355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ontent Placeholder 5">
            <a:extLst>
              <a:ext uri="{FF2B5EF4-FFF2-40B4-BE49-F238E27FC236}">
                <a16:creationId xmlns:a16="http://schemas.microsoft.com/office/drawing/2014/main" id="{E9715693-AB2F-426C-A9AF-21BDAE32DF24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289300" y="482870"/>
          <a:ext cx="5283200" cy="462253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283200">
                  <a:extLst>
                    <a:ext uri="{9D8B030D-6E8A-4147-A177-3AD203B41FA5}">
                      <a16:colId xmlns:a16="http://schemas.microsoft.com/office/drawing/2014/main" val="2115934185"/>
                    </a:ext>
                  </a:extLst>
                </a:gridCol>
              </a:tblGrid>
              <a:tr h="4165330">
                <a:tc>
                  <a:txBody>
                    <a:bodyPr/>
                    <a:lstStyle/>
                    <a:p>
                      <a:endParaRPr lang="en-US" sz="100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653280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800" b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Supplemental Figure 9. Infected cortical allograft gram stain. Cortical allograft infected with 1*10</a:t>
                      </a:r>
                      <a:r>
                        <a:rPr lang="en-US" sz="800" b="0" kern="1200" baseline="300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2</a:t>
                      </a:r>
                      <a:r>
                        <a:rPr lang="en-US" sz="800" b="0" kern="1200" baseline="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 CFUs/uL </a:t>
                      </a:r>
                      <a:r>
                        <a:rPr lang="en-US" sz="800" b="0" i="1" kern="1200" baseline="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S. aureus</a:t>
                      </a:r>
                      <a:r>
                        <a:rPr lang="en-US" sz="800" b="0" i="0" kern="1200" baseline="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 bacteria. Image taken at POD56,</a:t>
                      </a:r>
                      <a:r>
                        <a:rPr lang="en-US" sz="800" b="0" kern="12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+mn-ea"/>
                          <a:cs typeface="Arial"/>
                        </a:rPr>
                        <a:t> 1000x, gram stain demonstrating gram positive cocci present within haversian canal. Blue arrowhead = gram positive cocci.</a:t>
                      </a:r>
                      <a:endParaRPr lang="en-US" sz="800" b="0" dirty="0">
                        <a:latin typeface="Arial"/>
                        <a:cs typeface="Arial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96879176"/>
                  </a:ext>
                </a:extLst>
              </a:tr>
            </a:tbl>
          </a:graphicData>
        </a:graphic>
      </p:graphicFrame>
      <p:pic>
        <p:nvPicPr>
          <p:cNvPr id="4" name="Picture 3">
            <a:extLst>
              <a:ext uri="{FF2B5EF4-FFF2-40B4-BE49-F238E27FC236}">
                <a16:creationId xmlns:a16="http://schemas.microsoft.com/office/drawing/2014/main" id="{DAC83BF7-418F-4427-B86E-32DFF46FCB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4612" y="559428"/>
            <a:ext cx="5107348" cy="400576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D89A158-C8CF-4CC5-A8A8-540D79A4C3AC}"/>
              </a:ext>
            </a:extLst>
          </p:cNvPr>
          <p:cNvSpPr txBox="1"/>
          <p:nvPr/>
        </p:nvSpPr>
        <p:spPr>
          <a:xfrm>
            <a:off x="3384612" y="4349746"/>
            <a:ext cx="12333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m Stain 1000x</a:t>
            </a:r>
          </a:p>
        </p:txBody>
      </p:sp>
      <p:sp>
        <p:nvSpPr>
          <p:cNvPr id="8" name="Isosceles Triangle 7">
            <a:extLst>
              <a:ext uri="{FF2B5EF4-FFF2-40B4-BE49-F238E27FC236}">
                <a16:creationId xmlns:a16="http://schemas.microsoft.com/office/drawing/2014/main" id="{B41BC659-8867-4C8C-8CCB-4DCB5CD47ED9}"/>
              </a:ext>
            </a:extLst>
          </p:cNvPr>
          <p:cNvSpPr/>
          <p:nvPr/>
        </p:nvSpPr>
        <p:spPr>
          <a:xfrm rot="17739085">
            <a:off x="4875403" y="1533904"/>
            <a:ext cx="198008" cy="26076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Isosceles Triangle 8">
            <a:extLst>
              <a:ext uri="{FF2B5EF4-FFF2-40B4-BE49-F238E27FC236}">
                <a16:creationId xmlns:a16="http://schemas.microsoft.com/office/drawing/2014/main" id="{438D665F-7E50-4798-8D85-FDE9B103F246}"/>
              </a:ext>
            </a:extLst>
          </p:cNvPr>
          <p:cNvSpPr/>
          <p:nvPr/>
        </p:nvSpPr>
        <p:spPr>
          <a:xfrm rot="17739085">
            <a:off x="6570854" y="2271651"/>
            <a:ext cx="198008" cy="26076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Isosceles Triangle 9">
            <a:extLst>
              <a:ext uri="{FF2B5EF4-FFF2-40B4-BE49-F238E27FC236}">
                <a16:creationId xmlns:a16="http://schemas.microsoft.com/office/drawing/2014/main" id="{8988BAC4-02C4-4665-9185-51C7DE73D4F9}"/>
              </a:ext>
            </a:extLst>
          </p:cNvPr>
          <p:cNvSpPr/>
          <p:nvPr/>
        </p:nvSpPr>
        <p:spPr>
          <a:xfrm rot="17739085">
            <a:off x="7409053" y="3020506"/>
            <a:ext cx="198008" cy="260764"/>
          </a:xfrm>
          <a:prstGeom prst="triangl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7502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5:01Z</dcterms:created>
  <dcterms:modified xsi:type="dcterms:W3CDTF">2020-08-22T04:25:11Z</dcterms:modified>
</cp:coreProperties>
</file>